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0295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9276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3329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4554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9343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2693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5768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6298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7724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37242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8491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CA76B-B1EB-4971-944F-254B73294D3B}" type="datetimeFigureOut">
              <a:rPr lang="ko-KR" altLang="en-US" smtClean="0"/>
              <a:t>2023-11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352FC5-4B62-430D-85A8-D1574BE36B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0905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8997" y="178788"/>
            <a:ext cx="7674005" cy="650042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7793370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6618" y="148305"/>
            <a:ext cx="7658764" cy="656138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80612960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1859" y="163547"/>
            <a:ext cx="7628281" cy="653090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369948339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9946" y="148305"/>
            <a:ext cx="7712108" cy="656138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322186104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8049" y="133064"/>
            <a:ext cx="7635902" cy="659187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26125546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2808" y="159736"/>
            <a:ext cx="7666384" cy="653852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7318226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8997" y="144495"/>
            <a:ext cx="7674005" cy="656900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9352437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5187" y="163547"/>
            <a:ext cx="7681626" cy="653090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8051442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8049" y="148305"/>
            <a:ext cx="7635902" cy="656138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42114032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9946" y="148305"/>
            <a:ext cx="7712108" cy="656138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  <p:sp>
        <p:nvSpPr>
          <p:cNvPr id="4" name="직사각형 3"/>
          <p:cNvSpPr/>
          <p:nvPr/>
        </p:nvSpPr>
        <p:spPr>
          <a:xfrm>
            <a:off x="2265364" y="5486400"/>
            <a:ext cx="7686690" cy="1223294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" name="직사각형 4"/>
          <p:cNvSpPr/>
          <p:nvPr/>
        </p:nvSpPr>
        <p:spPr>
          <a:xfrm>
            <a:off x="3823063" y="4885509"/>
            <a:ext cx="6131501" cy="600891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TextBox 5"/>
          <p:cNvSpPr txBox="1"/>
          <p:nvPr/>
        </p:nvSpPr>
        <p:spPr>
          <a:xfrm>
            <a:off x="1014024" y="5843452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H domain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20255983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8997" y="171167"/>
            <a:ext cx="7674005" cy="651566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  <p:sp>
        <p:nvSpPr>
          <p:cNvPr id="4" name="직사각형 3"/>
          <p:cNvSpPr/>
          <p:nvPr/>
        </p:nvSpPr>
        <p:spPr>
          <a:xfrm>
            <a:off x="2265364" y="69668"/>
            <a:ext cx="7686690" cy="4223658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 smtClean="0"/>
              <a:t>c</a:t>
            </a:r>
            <a:endParaRPr lang="ko-KR" altLang="en-US" dirty="0"/>
          </a:p>
        </p:txBody>
      </p:sp>
      <p:sp>
        <p:nvSpPr>
          <p:cNvPr id="5" name="직사각형 4"/>
          <p:cNvSpPr/>
          <p:nvPr/>
        </p:nvSpPr>
        <p:spPr>
          <a:xfrm>
            <a:off x="2265364" y="4300947"/>
            <a:ext cx="4065767" cy="601979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TextBox 5"/>
          <p:cNvSpPr txBox="1"/>
          <p:nvPr/>
        </p:nvSpPr>
        <p:spPr>
          <a:xfrm>
            <a:off x="831144" y="1515292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H domain</a:t>
            </a:r>
            <a:endParaRPr lang="ko-KR" altLang="en-US" b="1" dirty="0"/>
          </a:p>
        </p:txBody>
      </p:sp>
      <p:sp>
        <p:nvSpPr>
          <p:cNvPr id="7" name="타원 6"/>
          <p:cNvSpPr/>
          <p:nvPr/>
        </p:nvSpPr>
        <p:spPr>
          <a:xfrm>
            <a:off x="6696893" y="3788229"/>
            <a:ext cx="269965" cy="505097"/>
          </a:xfrm>
          <a:prstGeom prst="ellipse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9" name="직선 화살표 연결선 8"/>
          <p:cNvCxnSpPr/>
          <p:nvPr/>
        </p:nvCxnSpPr>
        <p:spPr>
          <a:xfrm flipV="1">
            <a:off x="6901196" y="4206242"/>
            <a:ext cx="3836471" cy="479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0737667" y="4038994"/>
            <a:ext cx="880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S519G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19412307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6618" y="171167"/>
            <a:ext cx="7658764" cy="651566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13748372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1859" y="159736"/>
            <a:ext cx="7628281" cy="653852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6261207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8997" y="163547"/>
            <a:ext cx="7674005" cy="653090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178788"/>
            <a:ext cx="226536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; </a:t>
            </a:r>
            <a:r>
              <a:rPr lang="en-US" altLang="ko-KR" sz="1100" dirty="0" err="1" smtClean="0"/>
              <a:t>rNDV</a:t>
            </a:r>
            <a:r>
              <a:rPr lang="en-US" altLang="ko-KR" sz="1100" dirty="0" smtClean="0"/>
              <a:t> VG/GA</a:t>
            </a:r>
          </a:p>
          <a:p>
            <a:r>
              <a:rPr lang="en-US" altLang="ko-KR" sz="1100" dirty="0" smtClean="0"/>
              <a:t>S519G; The S519G mutant </a:t>
            </a:r>
            <a:r>
              <a:rPr lang="en-US" altLang="ko-KR" sz="1100" dirty="0" err="1" smtClean="0"/>
              <a:t>rNDV</a:t>
            </a:r>
            <a:endParaRPr lang="ko-KR" altLang="en-US" sz="1100" dirty="0"/>
          </a:p>
        </p:txBody>
      </p:sp>
    </p:spTree>
    <p:extLst>
      <p:ext uri="{BB962C8B-B14F-4D97-AF65-F5344CB8AC3E}">
        <p14:creationId xmlns:p14="http://schemas.microsoft.com/office/powerpoint/2010/main" val="1231601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46</Words>
  <Application>Microsoft Office PowerPoint</Application>
  <PresentationFormat>와이드스크린</PresentationFormat>
  <Paragraphs>32</Paragraphs>
  <Slides>1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4</vt:i4>
      </vt:variant>
    </vt:vector>
  </HeadingPairs>
  <TitlesOfParts>
    <vt:vector size="17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o-Kyoung Jung</dc:creator>
  <cp:lastModifiedBy>Bo-Kyoung Jung</cp:lastModifiedBy>
  <cp:revision>7</cp:revision>
  <dcterms:created xsi:type="dcterms:W3CDTF">2023-10-25T07:57:57Z</dcterms:created>
  <dcterms:modified xsi:type="dcterms:W3CDTF">2023-11-28T07:30:54Z</dcterms:modified>
</cp:coreProperties>
</file>